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3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58724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4BB6FD11-83B3-0BA6-BAB2-3E8C36D7B6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2180" y="37444"/>
            <a:ext cx="4648132" cy="6055852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155312" y="6122543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5592722"/>
            <a:ext cx="738031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hillip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05-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1520" y="80762"/>
            <a:ext cx="26642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Algorithm for monitoring of people screened positive for one or more islet autoantibodies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254278"/>
            <a:ext cx="889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continuum of educational needs and competencies: what does one need to know?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D4156E7-15DB-19B4-BE8F-1FA75E3AF8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520" y="1017742"/>
            <a:ext cx="8458485" cy="4822516"/>
          </a:xfrm>
          <a:prstGeom prst="rect">
            <a:avLst/>
          </a:prstGeom>
        </p:spPr>
      </p:pic>
      <p:pic>
        <p:nvPicPr>
          <p:cNvPr id="2" name="Picture 1" descr="diabetologia logo.tif">
            <a:extLst>
              <a:ext uri="{FF2B5EF4-FFF2-40B4-BE49-F238E27FC236}">
                <a16:creationId xmlns:a16="http://schemas.microsoft.com/office/drawing/2014/main" id="{071D4AF1-F3A4-7A00-D218-A51FB43744A3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155312" y="6122543"/>
            <a:ext cx="1675152" cy="47480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6A2E3FB-5964-5906-D82A-1E92BC87C7B4}"/>
              </a:ext>
            </a:extLst>
          </p:cNvPr>
          <p:cNvSpPr txBox="1"/>
          <p:nvPr/>
        </p:nvSpPr>
        <p:spPr>
          <a:xfrm>
            <a:off x="0" y="5592722"/>
            <a:ext cx="738031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hillip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05-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American Diabetes Association and European Association for the Study of Diabete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574118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</TotalTime>
  <Words>128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5</cp:revision>
  <dcterms:created xsi:type="dcterms:W3CDTF">2016-06-15T12:53:43Z</dcterms:created>
  <dcterms:modified xsi:type="dcterms:W3CDTF">2024-06-13T14:38:57Z</dcterms:modified>
</cp:coreProperties>
</file>